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63E7F71-C3C2-4AE2-B6F8-61000AE28995}" v="1" dt="2021-04-13T18:08:53.1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8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uchan, Matthew J" userId="b067ef27-2102-49b1-9a32-4968c54c47cd" providerId="ADAL" clId="{B63E7F71-C3C2-4AE2-B6F8-61000AE28995}"/>
    <pc:docChg chg="custSel modSld">
      <pc:chgData name="Kuchan, Matthew J" userId="b067ef27-2102-49b1-9a32-4968c54c47cd" providerId="ADAL" clId="{B63E7F71-C3C2-4AE2-B6F8-61000AE28995}" dt="2021-04-13T18:10:08.350" v="71" actId="20577"/>
      <pc:docMkLst>
        <pc:docMk/>
      </pc:docMkLst>
      <pc:sldChg chg="modSp">
        <pc:chgData name="Kuchan, Matthew J" userId="b067ef27-2102-49b1-9a32-4968c54c47cd" providerId="ADAL" clId="{B63E7F71-C3C2-4AE2-B6F8-61000AE28995}" dt="2021-04-13T18:10:08.350" v="71" actId="20577"/>
        <pc:sldMkLst>
          <pc:docMk/>
          <pc:sldMk cId="3761304801" sldId="260"/>
        </pc:sldMkLst>
        <pc:spChg chg="mod">
          <ac:chgData name="Kuchan, Matthew J" userId="b067ef27-2102-49b1-9a32-4968c54c47cd" providerId="ADAL" clId="{B63E7F71-C3C2-4AE2-B6F8-61000AE28995}" dt="2021-04-13T18:10:08.350" v="71" actId="20577"/>
          <ac:spMkLst>
            <pc:docMk/>
            <pc:sldMk cId="3761304801" sldId="260"/>
            <ac:spMk id="2" creationId="{A1A09B3D-C478-4813-9B51-A6C3D9DAC23E}"/>
          </ac:spMkLst>
        </pc:spChg>
        <pc:picChg chg="mod">
          <ac:chgData name="Kuchan, Matthew J" userId="b067ef27-2102-49b1-9a32-4968c54c47cd" providerId="ADAL" clId="{B63E7F71-C3C2-4AE2-B6F8-61000AE28995}" dt="2021-04-13T18:09:49.162" v="51" actId="1036"/>
          <ac:picMkLst>
            <pc:docMk/>
            <pc:sldMk cId="3761304801" sldId="260"/>
            <ac:picMk id="4" creationId="{6CE3A5F3-ACE5-4568-90E3-F163CEC5A41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C9146-2C65-41D2-8453-F5E91380E2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544B63-B115-478D-BE8F-13D162B1DB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3E8E5-AA28-4B06-B2F6-FFC6D2B2A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7583B8-E6D9-4F6B-B5F0-EE3C6FCF0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FDE66-09AC-4047-B973-EB0C6D7ED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151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FBFF6-3300-4788-ACFB-8B27C7CDFF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4677AF-77BD-4E27-9B62-1A5225457C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020456-F613-42DF-903A-97C744256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4BA276-F93E-4E91-8C91-36BE85180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BED7B-2EAA-488E-A958-BDC0DA10D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329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E117A8-D37E-4C7A-BD47-A6C009F6D3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F0D216-D998-4D8E-82A4-CAF0FF24FB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39C63E-7BB8-467E-9761-D30D028D2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F7EC59-7C88-4B53-98E4-7FED90DAA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99AB5-A542-4FB9-8BB6-E731BA3FB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659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640AA-316F-4746-9AB0-8BFBF75C5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971B4-3A20-4DCD-ACEF-6D4AD88630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B982C-9182-4820-B06F-069FEC365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196EEF-3764-4573-91E2-67145A539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00D5E2-11F0-4CF3-B82D-9DC2A75BB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20DE7-13C1-43B8-9001-CAC1AC0E7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8A603D-0B82-440A-A68A-A214D36D55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1469A-CD91-4F42-B3B8-C2DF88B24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1E224-A5A7-4FBD-8987-4DB8A61E1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703EB-5F05-4F4E-B042-B63678862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101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4DF06-B672-4FEA-9704-42C5A253D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536619-3A98-4DD1-967E-652D71DDE0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F978F9-CF35-447A-B9E9-615C28447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D48D79-8CBA-4163-ADE1-DE72363FD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7E6E9C-9DDF-47B2-96CD-809BE4498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ADF232-89F3-4BCE-BB7F-4CEDF6735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623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B2094-5FB1-43A6-B442-FEA9783FE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DE8F5E-5A24-4EFB-B20C-2D32FC96E3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33A8B0-901A-4982-983B-FE09D04D21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94C0CF-00F4-4E7B-B4E2-BF66B0BE9B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C46560-E634-4A15-BE86-8977F074C3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02661A6-2D23-4404-808C-E9026CAEF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37594F-8EE9-497E-BDD7-02DCB07C5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E2F1A1-7E81-496D-9336-FC2107DBF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650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B95DA-5BAF-412F-8B76-E94228395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CF5896-C047-4CBD-B8DE-DEA4289A3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46AF94-D679-4046-8F08-F1B6D8DA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1BB16D3-9315-485F-A2EC-C9CD8588F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16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951F58-7A34-47D4-AC4E-79F3774C4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FEC9EB-B26B-450D-B21E-E7ADDED02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609816-46BE-4F7E-9574-68DD2F0D7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275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34703-1EE8-49B4-BF27-C0126D885B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2F4201-157D-4069-A114-BDB784A278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CEE597-34C2-47C0-A3FA-3C0FB3D8D6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6F0D3F-1886-4019-B28C-8C56571E2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914BFC-B1D9-4859-ACA8-80ADB6FBD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5C8280-7054-492D-922F-8D4CA03CD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972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E53B74-6C78-40E2-AFB6-5EE0C014CB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F56FE9-6E01-476E-9C6F-85BE08E269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AF3243-A203-4335-B3C0-4848FBCDF3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E8EC4F-A5EA-4BD5-8A34-9EF680C9E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9FD471-4AC9-4E52-B14A-6D52F90F5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26BD0C-79C0-499C-BBF2-444E36061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859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DA73F5-3098-418F-B5E1-0734F5E428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218C6-451E-45DE-A69C-8AD5F0B537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B1C8B7-8BD7-461D-81F2-4CD6B386A1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50753-40D0-4F26-A52C-A54DE28BE148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18D305-AAD6-4AD5-B8F9-5C90DA6760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92369E-B4A0-4A88-8577-DD8C1D5DC7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34CC8-8042-473B-AF50-99E68231D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022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09B3D-C478-4813-9B51-A6C3D9DAC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13657"/>
            <a:ext cx="5486400" cy="721242"/>
          </a:xfrm>
        </p:spPr>
        <p:txBody>
          <a:bodyPr>
            <a:normAutofit fontScale="90000"/>
          </a:bodyPr>
          <a:lstStyle/>
          <a:p>
            <a:r>
              <a:rPr lang="en-US" sz="1200" dirty="0"/>
              <a:t>a-Tocopherol Stereoisomer Profiles in Matched Human Maternal and Umbilical Cord Plasma</a:t>
            </a:r>
            <a:br>
              <a:rPr lang="en-US" sz="1200" dirty="0"/>
            </a:br>
            <a:r>
              <a:rPr lang="en-US" sz="1200" dirty="0"/>
              <a:t>Kuchan, MJ</a:t>
            </a:r>
            <a:br>
              <a:rPr lang="en-US" sz="1200" dirty="0"/>
            </a:br>
            <a:r>
              <a:rPr lang="en-US" sz="1200" dirty="0"/>
              <a:t>Online Supplemental Material</a:t>
            </a:r>
            <a:br>
              <a:rPr lang="en-US" dirty="0"/>
            </a:br>
            <a:br>
              <a:rPr lang="en-US" sz="1200"/>
            </a:br>
            <a:r>
              <a:rPr lang="en-US" sz="1200"/>
              <a:t>Figure 1.</a:t>
            </a:r>
            <a:endParaRPr lang="en-US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CE3A5F3-ACE5-4568-90E3-F163CEC5A4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2312" y="2100434"/>
            <a:ext cx="4451117" cy="3291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1304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-Tocopherol Stereoisomer Profiles in Matched Human Maternal and Umbilical Cord Plasma Kuchan, MJ Online Supplemental Material  Figure 1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 Fig 1</dc:title>
  <dc:creator>Kuchan, Matthew J</dc:creator>
  <cp:lastModifiedBy>Kuchan, Matthew J</cp:lastModifiedBy>
  <cp:revision>1</cp:revision>
  <dcterms:created xsi:type="dcterms:W3CDTF">2020-11-03T20:27:45Z</dcterms:created>
  <dcterms:modified xsi:type="dcterms:W3CDTF">2021-04-13T18:10:09Z</dcterms:modified>
</cp:coreProperties>
</file>